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7" r:id="rId2"/>
    <p:sldId id="276" r:id="rId3"/>
    <p:sldId id="262" r:id="rId4"/>
    <p:sldId id="275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0" autoAdjust="0"/>
    <p:restoredTop sz="94660"/>
  </p:normalViewPr>
  <p:slideViewPr>
    <p:cSldViewPr snapToGrid="0">
      <p:cViewPr varScale="1">
        <p:scale>
          <a:sx n="78" d="100"/>
          <a:sy n="78" d="100"/>
        </p:scale>
        <p:origin x="304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CAC79-1653-480A-88B4-F6A4A78A2DB8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7F24C-7CEA-42BE-A0C2-7955FC70C3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29643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CAC79-1653-480A-88B4-F6A4A78A2DB8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7F24C-7CEA-42BE-A0C2-7955FC70C3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7221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CAC79-1653-480A-88B4-F6A4A78A2DB8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7F24C-7CEA-42BE-A0C2-7955FC70C3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661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CAC79-1653-480A-88B4-F6A4A78A2DB8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7F24C-7CEA-42BE-A0C2-7955FC70C3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40584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CAC79-1653-480A-88B4-F6A4A78A2DB8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7F24C-7CEA-42BE-A0C2-7955FC70C3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4020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CAC79-1653-480A-88B4-F6A4A78A2DB8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7F24C-7CEA-42BE-A0C2-7955FC70C3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6281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CAC79-1653-480A-88B4-F6A4A78A2DB8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7F24C-7CEA-42BE-A0C2-7955FC70C3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4944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CAC79-1653-480A-88B4-F6A4A78A2DB8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7F24C-7CEA-42BE-A0C2-7955FC70C3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018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CAC79-1653-480A-88B4-F6A4A78A2DB8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7F24C-7CEA-42BE-A0C2-7955FC70C3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30340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CAC79-1653-480A-88B4-F6A4A78A2DB8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7F24C-7CEA-42BE-A0C2-7955FC70C3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6873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CAC79-1653-480A-88B4-F6A4A78A2DB8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7F24C-7CEA-42BE-A0C2-7955FC70C3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59761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FCAC79-1653-480A-88B4-F6A4A78A2DB8}" type="datetimeFigureOut">
              <a:rPr lang="zh-CN" altLang="en-US" smtClean="0"/>
              <a:t>2022/9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7F24C-7CEA-42BE-A0C2-7955FC70C3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40808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377D8054-2CE3-4E37-A5E9-ACBE98EBEF92}"/>
              </a:ext>
            </a:extLst>
          </p:cNvPr>
          <p:cNvSpPr txBox="1"/>
          <p:nvPr/>
        </p:nvSpPr>
        <p:spPr>
          <a:xfrm>
            <a:off x="5529226" y="1748358"/>
            <a:ext cx="1097280" cy="8452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onatine,</a:t>
            </a:r>
            <a:r>
              <a: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r>
              <a:rPr lang="en-US" altLang="zh-CN" sz="10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  <a:p>
            <a:pPr>
              <a:lnSpc>
                <a:spcPts val="1500"/>
              </a:lnSpc>
            </a:pP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onatine,</a:t>
            </a:r>
            <a:r>
              <a: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zh-CN" sz="10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  <a:p>
            <a:pPr>
              <a:lnSpc>
                <a:spcPts val="1500"/>
              </a:lnSpc>
            </a:pP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, 25</a:t>
            </a:r>
            <a:r>
              <a:rPr lang="en-US" altLang="zh-CN" sz="10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  <a:p>
            <a:pPr>
              <a:lnSpc>
                <a:spcPts val="1500"/>
              </a:lnSpc>
            </a:pP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, 4</a:t>
            </a:r>
            <a:r>
              <a:rPr lang="en-US" altLang="zh-CN" sz="10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885F0281-A236-4613-B53E-3D2A3B6C7457}"/>
              </a:ext>
            </a:extLst>
          </p:cNvPr>
          <p:cNvSpPr/>
          <p:nvPr/>
        </p:nvSpPr>
        <p:spPr>
          <a:xfrm>
            <a:off x="0" y="0"/>
            <a:ext cx="31385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S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607B55CC-297B-48E5-AEF0-8F003C0B78E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22880" r="17056" b="23258"/>
          <a:stretch/>
        </p:blipFill>
        <p:spPr>
          <a:xfrm>
            <a:off x="901614" y="850111"/>
            <a:ext cx="4362149" cy="2832712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B7AEA2B2-2B97-4833-8141-74A57E7C2C1C}"/>
              </a:ext>
            </a:extLst>
          </p:cNvPr>
          <p:cNvSpPr txBox="1"/>
          <p:nvPr/>
        </p:nvSpPr>
        <p:spPr>
          <a:xfrm>
            <a:off x="334002" y="3682823"/>
            <a:ext cx="569866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ure S1.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Principal component analysis (PCA) showing that the 12 samples are grouped into four categories.</a:t>
            </a:r>
            <a:endParaRPr lang="zh-CN" altLang="en-US" sz="1200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3D038676-8898-4FCF-8E97-06D64D7E925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808" t="41436" r="10593" b="43190"/>
          <a:stretch/>
        </p:blipFill>
        <p:spPr>
          <a:xfrm>
            <a:off x="5379686" y="1798459"/>
            <a:ext cx="241886" cy="8085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67346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7EEE6453-DE2C-4DDC-8106-CBE45D5EE95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139" r="20520" b="73419"/>
          <a:stretch/>
        </p:blipFill>
        <p:spPr>
          <a:xfrm>
            <a:off x="4528325" y="1232045"/>
            <a:ext cx="677110" cy="1623987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307EE51B-AF7F-4185-937F-56D942AE4033}"/>
              </a:ext>
            </a:extLst>
          </p:cNvPr>
          <p:cNvSpPr txBox="1"/>
          <p:nvPr/>
        </p:nvSpPr>
        <p:spPr>
          <a:xfrm>
            <a:off x="4585676" y="1013691"/>
            <a:ext cx="46839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TPM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F2C0504E-872D-4D73-89A0-0498257FD394}"/>
              </a:ext>
            </a:extLst>
          </p:cNvPr>
          <p:cNvSpPr txBox="1"/>
          <p:nvPr/>
        </p:nvSpPr>
        <p:spPr>
          <a:xfrm rot="20182940">
            <a:off x="2584665" y="776186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Control 25</a:t>
            </a:r>
            <a:r>
              <a:rPr lang="en-US" altLang="zh-CN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1933409C-F2B2-40A6-9DE4-F8350E9A8F7C}"/>
              </a:ext>
            </a:extLst>
          </p:cNvPr>
          <p:cNvSpPr txBox="1"/>
          <p:nvPr/>
        </p:nvSpPr>
        <p:spPr>
          <a:xfrm rot="20182940">
            <a:off x="3046624" y="780173"/>
            <a:ext cx="9637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Control 4</a:t>
            </a:r>
            <a:r>
              <a:rPr lang="en-US" altLang="zh-CN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B553D6F-A6F0-428E-91DC-E9576FF73976}"/>
              </a:ext>
            </a:extLst>
          </p:cNvPr>
          <p:cNvSpPr txBox="1"/>
          <p:nvPr/>
        </p:nvSpPr>
        <p:spPr>
          <a:xfrm rot="20182940">
            <a:off x="3399132" y="718974"/>
            <a:ext cx="12618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coronatine 25</a:t>
            </a:r>
            <a:r>
              <a:rPr lang="en-US" altLang="zh-CN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92AAECE5-C965-4206-9B2E-381A7620E239}"/>
              </a:ext>
            </a:extLst>
          </p:cNvPr>
          <p:cNvSpPr txBox="1"/>
          <p:nvPr/>
        </p:nvSpPr>
        <p:spPr>
          <a:xfrm rot="20182940">
            <a:off x="3947284" y="728272"/>
            <a:ext cx="11833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coronatine 4</a:t>
            </a:r>
            <a:r>
              <a:rPr lang="en-US" altLang="zh-CN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0164D463-2A1B-4639-A602-18CFEBACF67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650" r="59564" b="9564"/>
          <a:stretch/>
        </p:blipFill>
        <p:spPr>
          <a:xfrm>
            <a:off x="1818087" y="1130154"/>
            <a:ext cx="2667037" cy="4900767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54032006-84E7-406A-BA81-4F6BB5C646CA}"/>
              </a:ext>
            </a:extLst>
          </p:cNvPr>
          <p:cNvSpPr txBox="1"/>
          <p:nvPr/>
        </p:nvSpPr>
        <p:spPr>
          <a:xfrm>
            <a:off x="294033" y="6128534"/>
            <a:ext cx="6298408" cy="6131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map showing the gene expression levels of coronatine-induced chilling responsive genes with TPM. </a:t>
            </a:r>
          </a:p>
        </p:txBody>
      </p:sp>
    </p:spTree>
    <p:extLst>
      <p:ext uri="{BB962C8B-B14F-4D97-AF65-F5344CB8AC3E}">
        <p14:creationId xmlns:p14="http://schemas.microsoft.com/office/powerpoint/2010/main" val="34374298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6212D24F-95AE-4FF7-BB81-8BB4368CD43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5429" b="12609"/>
          <a:stretch/>
        </p:blipFill>
        <p:spPr>
          <a:xfrm>
            <a:off x="3622913" y="602649"/>
            <a:ext cx="2745059" cy="2158222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358947A0-1E5B-4052-BB00-C1AD3B8A2AD9}"/>
              </a:ext>
            </a:extLst>
          </p:cNvPr>
          <p:cNvSpPr txBox="1"/>
          <p:nvPr/>
        </p:nvSpPr>
        <p:spPr>
          <a:xfrm>
            <a:off x="-342977" y="646891"/>
            <a:ext cx="4423789" cy="18235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 fontAlgn="ctr">
              <a:lnSpc>
                <a:spcPts val="1500"/>
              </a:lnSpc>
            </a:pPr>
            <a:r>
              <a:rPr lang="en-US" altLang="zh-CN" sz="10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ytoskeleton proteins (</a:t>
            </a:r>
            <a:r>
              <a:rPr lang="en-US" altLang="zh-CN" sz="10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4812)</a:t>
            </a:r>
          </a:p>
          <a:p>
            <a:pPr marL="0" algn="r" rtl="0" eaLnBrk="1" fontAlgn="ctr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0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hromosome and associated proteins (</a:t>
            </a:r>
            <a:r>
              <a:rPr lang="en-US" altLang="zh-CN" sz="10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3036)</a:t>
            </a:r>
            <a:r>
              <a:rPr lang="en-US" altLang="zh-CN" sz="1000" b="1" i="0" u="none" strike="noStrike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</a:p>
          <a:p>
            <a:pPr marL="0" algn="r" rtl="0" eaLnBrk="1" fontAlgn="ctr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000" b="1" i="0" u="none" strike="noStrike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gnal transduction (B09132) </a:t>
            </a:r>
            <a:endParaRPr lang="zh-CN" altLang="zh-CN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algn="r" rtl="0" eaLnBrk="1" fontAlgn="ctr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000" b="1" i="0" u="none" strike="noStrike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Environmental Information Processing (A09130) </a:t>
            </a:r>
            <a:endParaRPr lang="zh-CN" altLang="zh-CN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algn="r" rtl="0" eaLnBrk="1" fontAlgn="ctr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000" b="1" i="0" u="none" strike="noStrike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lant hormone signal transduction (04075) </a:t>
            </a:r>
            <a:endParaRPr lang="zh-CN" altLang="zh-CN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algn="r" rtl="0" eaLnBrk="1" fontAlgn="ctr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000" b="1" i="0" u="none" strike="noStrike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henylpropanoid biosynthesis (00940) </a:t>
            </a:r>
            <a:endParaRPr lang="zh-CN" altLang="zh-CN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algn="r" rtl="0" eaLnBrk="1" fontAlgn="ctr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000" b="1" i="0" u="none" strike="noStrike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ot Included in Pathway or </a:t>
            </a:r>
            <a:r>
              <a:rPr lang="en-US" altLang="zh-CN" sz="1000" b="1" i="0" u="none" strike="noStrike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rite</a:t>
            </a:r>
            <a:r>
              <a:rPr lang="en-US" altLang="zh-CN" sz="1000" b="1" i="0" u="none" strike="noStrike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(A09190) </a:t>
            </a:r>
            <a:endParaRPr lang="zh-CN" altLang="zh-CN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algn="r" rtl="0" eaLnBrk="1" fontAlgn="ctr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000" b="1" i="0" u="none" strike="noStrike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iosynthesis of other secondary metabolites (B09110) </a:t>
            </a:r>
            <a:endParaRPr lang="zh-CN" altLang="zh-CN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algn="r" rtl="0" eaLnBrk="1" fontAlgn="ctr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000" b="1" i="0" u="none" strike="noStrike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Enzymes with EC numbers (99980)</a:t>
            </a:r>
            <a:r>
              <a:rPr lang="en-US" altLang="zh-CN" sz="10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endParaRPr lang="en-US" altLang="zh-CN" sz="1000" b="1" i="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1C67EC0C-D854-4B17-BFE9-49C8903F8CC4}"/>
              </a:ext>
            </a:extLst>
          </p:cNvPr>
          <p:cNvSpPr txBox="1"/>
          <p:nvPr/>
        </p:nvSpPr>
        <p:spPr>
          <a:xfrm>
            <a:off x="4340633" y="2643300"/>
            <a:ext cx="12250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-log10 (</a:t>
            </a:r>
            <a:r>
              <a:rPr lang="en-US" altLang="zh-CN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-value)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CA29541-68D5-4E80-B158-8E73EFF4320E}"/>
              </a:ext>
            </a:extLst>
          </p:cNvPr>
          <p:cNvSpPr txBox="1"/>
          <p:nvPr/>
        </p:nvSpPr>
        <p:spPr>
          <a:xfrm>
            <a:off x="4127617" y="467430"/>
            <a:ext cx="12971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KEGG pathway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07926B8-38E1-41F9-89EA-8A150D85CD02}"/>
              </a:ext>
            </a:extLst>
          </p:cNvPr>
          <p:cNvSpPr txBox="1"/>
          <p:nvPr/>
        </p:nvSpPr>
        <p:spPr>
          <a:xfrm>
            <a:off x="412571" y="3020581"/>
            <a:ext cx="6147886" cy="3361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EGG classification of 412 coronatine-induced chilling responsive genes.</a:t>
            </a:r>
          </a:p>
        </p:txBody>
      </p:sp>
    </p:spTree>
    <p:extLst>
      <p:ext uri="{BB962C8B-B14F-4D97-AF65-F5344CB8AC3E}">
        <p14:creationId xmlns:p14="http://schemas.microsoft.com/office/powerpoint/2010/main" val="9445190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>
            <a:extLst>
              <a:ext uri="{FF2B5EF4-FFF2-40B4-BE49-F238E27FC236}">
                <a16:creationId xmlns:a16="http://schemas.microsoft.com/office/drawing/2014/main" id="{BAD2C250-F9FA-4F2F-8DB4-4A934FBA507E}"/>
              </a:ext>
            </a:extLst>
          </p:cNvPr>
          <p:cNvSpPr txBox="1"/>
          <p:nvPr/>
        </p:nvSpPr>
        <p:spPr>
          <a:xfrm>
            <a:off x="213268" y="5589338"/>
            <a:ext cx="634211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number of genes associated with H3K4me3 modifications. (b) Genome browser view of the H3K4me3 peaks at the </a:t>
            </a:r>
            <a:r>
              <a:rPr lang="en-US" altLang="zh-CN" sz="12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ZINC FINGER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zh-CN" sz="12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APK5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e regions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98DFE60A-7660-64B0-AF4E-FF845CE787A2}"/>
              </a:ext>
            </a:extLst>
          </p:cNvPr>
          <p:cNvGrpSpPr/>
          <p:nvPr/>
        </p:nvGrpSpPr>
        <p:grpSpPr>
          <a:xfrm>
            <a:off x="642591" y="3096971"/>
            <a:ext cx="4802218" cy="2268243"/>
            <a:chOff x="413744" y="3616684"/>
            <a:chExt cx="4802218" cy="2268243"/>
          </a:xfrm>
        </p:grpSpPr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2A103E80-14D4-8536-EE61-D8BA430A5F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404" t="8526" r="5091" b="83915"/>
            <a:stretch/>
          </p:blipFill>
          <p:spPr>
            <a:xfrm>
              <a:off x="1775024" y="3616684"/>
              <a:ext cx="1653976" cy="204108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43447D78-E18F-A06D-0F3B-00B5AB72DF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404" t="16939" r="5091" b="22663"/>
            <a:stretch/>
          </p:blipFill>
          <p:spPr>
            <a:xfrm>
              <a:off x="1775024" y="3853073"/>
              <a:ext cx="1653976" cy="163091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6929C369-CE5E-56B6-C277-EED060C2F9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404" t="83061" r="5091" b="11880"/>
            <a:stretch/>
          </p:blipFill>
          <p:spPr>
            <a:xfrm>
              <a:off x="1772070" y="5516266"/>
              <a:ext cx="1653976" cy="136600"/>
            </a:xfrm>
            <a:prstGeom prst="rect">
              <a:avLst/>
            </a:prstGeom>
          </p:spPr>
        </p:pic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60328F69-0D85-82A8-ED4B-968DFACC4FDA}"/>
                </a:ext>
              </a:extLst>
            </p:cNvPr>
            <p:cNvSpPr/>
            <p:nvPr/>
          </p:nvSpPr>
          <p:spPr>
            <a:xfrm>
              <a:off x="1772070" y="5511272"/>
              <a:ext cx="1653976" cy="333497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EA23F662-5BB7-8F62-8FFF-29E0A789A801}"/>
                </a:ext>
              </a:extLst>
            </p:cNvPr>
            <p:cNvSpPr txBox="1"/>
            <p:nvPr/>
          </p:nvSpPr>
          <p:spPr>
            <a:xfrm>
              <a:off x="2146535" y="5577228"/>
              <a:ext cx="1005676" cy="25487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700" b="1" i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PK5</a:t>
              </a:r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altLang="zh-CN" sz="700" b="1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Solyc12g005030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87D0EC3F-1CC6-53B1-457F-851C9B0A0EA6}"/>
                </a:ext>
              </a:extLst>
            </p:cNvPr>
            <p:cNvSpPr txBox="1"/>
            <p:nvPr/>
          </p:nvSpPr>
          <p:spPr>
            <a:xfrm>
              <a:off x="839290" y="3889393"/>
              <a:ext cx="9889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nput (Control) 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0DF40BBE-11B1-DEF1-E111-57A8B1C2CBAA}"/>
                </a:ext>
              </a:extLst>
            </p:cNvPr>
            <p:cNvSpPr txBox="1"/>
            <p:nvPr/>
          </p:nvSpPr>
          <p:spPr>
            <a:xfrm>
              <a:off x="726944" y="4295519"/>
              <a:ext cx="11012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nput (Coronatine) 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21D7D332-8BBB-1220-AECB-14B50463D0B1}"/>
                </a:ext>
              </a:extLst>
            </p:cNvPr>
            <p:cNvSpPr txBox="1"/>
            <p:nvPr/>
          </p:nvSpPr>
          <p:spPr>
            <a:xfrm>
              <a:off x="1085864" y="4085373"/>
              <a:ext cx="7423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P (Control) 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35EC1ADD-78A6-F2B1-33A9-825BC7F83346}"/>
                </a:ext>
              </a:extLst>
            </p:cNvPr>
            <p:cNvSpPr txBox="1"/>
            <p:nvPr/>
          </p:nvSpPr>
          <p:spPr>
            <a:xfrm>
              <a:off x="879448" y="4500217"/>
              <a:ext cx="9487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P (Coronatine) 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4EBD194F-0DE5-AAFD-3B68-5C4B8B308089}"/>
                </a:ext>
              </a:extLst>
            </p:cNvPr>
            <p:cNvSpPr txBox="1"/>
            <p:nvPr/>
          </p:nvSpPr>
          <p:spPr>
            <a:xfrm>
              <a:off x="981514" y="3686379"/>
              <a:ext cx="84670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hromosome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92E54DBB-9FAE-597A-0840-851EDF61493D}"/>
                </a:ext>
              </a:extLst>
            </p:cNvPr>
            <p:cNvSpPr txBox="1"/>
            <p:nvPr/>
          </p:nvSpPr>
          <p:spPr>
            <a:xfrm>
              <a:off x="1357194" y="5485063"/>
              <a:ext cx="4641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Gene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334DED71-A3E8-1545-4A27-617D435811A2}"/>
                </a:ext>
              </a:extLst>
            </p:cNvPr>
            <p:cNvSpPr txBox="1"/>
            <p:nvPr/>
          </p:nvSpPr>
          <p:spPr>
            <a:xfrm>
              <a:off x="839290" y="4694649"/>
              <a:ext cx="9889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nput (Control) 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275800BD-3A91-AA71-DDD1-31DD0A4B6996}"/>
                </a:ext>
              </a:extLst>
            </p:cNvPr>
            <p:cNvSpPr txBox="1"/>
            <p:nvPr/>
          </p:nvSpPr>
          <p:spPr>
            <a:xfrm>
              <a:off x="726944" y="5085933"/>
              <a:ext cx="11012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nput (Coronatine) 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6DCA6490-F7D4-FC81-C3B3-1FA11C27DBBB}"/>
                </a:ext>
              </a:extLst>
            </p:cNvPr>
            <p:cNvSpPr txBox="1"/>
            <p:nvPr/>
          </p:nvSpPr>
          <p:spPr>
            <a:xfrm>
              <a:off x="1085864" y="4884588"/>
              <a:ext cx="7423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P (Control) 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88D917B4-8AA4-5751-BF1D-EF1EB5ED9A16}"/>
                </a:ext>
              </a:extLst>
            </p:cNvPr>
            <p:cNvSpPr txBox="1"/>
            <p:nvPr/>
          </p:nvSpPr>
          <p:spPr>
            <a:xfrm>
              <a:off x="920290" y="5295750"/>
              <a:ext cx="9079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P (Coronatine) 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直接连接符 36">
              <a:extLst>
                <a:ext uri="{FF2B5EF4-FFF2-40B4-BE49-F238E27FC236}">
                  <a16:creationId xmlns:a16="http://schemas.microsoft.com/office/drawing/2014/main" id="{E097B86E-3701-F954-8669-7D1DF1401AE2}"/>
                </a:ext>
              </a:extLst>
            </p:cNvPr>
            <p:cNvCxnSpPr>
              <a:cxnSpLocks/>
            </p:cNvCxnSpPr>
            <p:nvPr/>
          </p:nvCxnSpPr>
          <p:spPr>
            <a:xfrm>
              <a:off x="841523" y="4744812"/>
              <a:ext cx="0" cy="74025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45618D61-6D7F-701F-37E6-66DC8739F59B}"/>
                </a:ext>
              </a:extLst>
            </p:cNvPr>
            <p:cNvSpPr txBox="1"/>
            <p:nvPr/>
          </p:nvSpPr>
          <p:spPr>
            <a:xfrm>
              <a:off x="430726" y="4154163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rep 1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2AC7A645-76B9-FEBB-D712-0D73F76544B1}"/>
                </a:ext>
              </a:extLst>
            </p:cNvPr>
            <p:cNvSpPr txBox="1"/>
            <p:nvPr/>
          </p:nvSpPr>
          <p:spPr>
            <a:xfrm>
              <a:off x="413744" y="5041790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rep 2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直接连接符 39">
              <a:extLst>
                <a:ext uri="{FF2B5EF4-FFF2-40B4-BE49-F238E27FC236}">
                  <a16:creationId xmlns:a16="http://schemas.microsoft.com/office/drawing/2014/main" id="{C3599988-6CD5-BC01-0CD8-C3130322249D}"/>
                </a:ext>
              </a:extLst>
            </p:cNvPr>
            <p:cNvCxnSpPr>
              <a:cxnSpLocks/>
            </p:cNvCxnSpPr>
            <p:nvPr/>
          </p:nvCxnSpPr>
          <p:spPr>
            <a:xfrm>
              <a:off x="839290" y="3912068"/>
              <a:ext cx="0" cy="74025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1" name="图片 40">
              <a:extLst>
                <a:ext uri="{FF2B5EF4-FFF2-40B4-BE49-F238E27FC236}">
                  <a16:creationId xmlns:a16="http://schemas.microsoft.com/office/drawing/2014/main" id="{03DABF6C-4397-F766-EAE6-17AF16E1DD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7447" r="3395" b="84912"/>
            <a:stretch/>
          </p:blipFill>
          <p:spPr>
            <a:xfrm>
              <a:off x="3526677" y="3616684"/>
              <a:ext cx="1597826" cy="20602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42" name="图片 41">
              <a:extLst>
                <a:ext uri="{FF2B5EF4-FFF2-40B4-BE49-F238E27FC236}">
                  <a16:creationId xmlns:a16="http://schemas.microsoft.com/office/drawing/2014/main" id="{465650F0-5C94-15C8-5269-B41B814129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6106" b="21461"/>
            <a:stretch/>
          </p:blipFill>
          <p:spPr>
            <a:xfrm>
              <a:off x="3526677" y="3857721"/>
              <a:ext cx="1597826" cy="162626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43" name="图片 42">
              <a:extLst>
                <a:ext uri="{FF2B5EF4-FFF2-40B4-BE49-F238E27FC236}">
                  <a16:creationId xmlns:a16="http://schemas.microsoft.com/office/drawing/2014/main" id="{BEAF75F9-B05D-9876-2AEB-23B8D0F25F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84811" r="3395" b="10248"/>
            <a:stretch/>
          </p:blipFill>
          <p:spPr>
            <a:xfrm>
              <a:off x="3526677" y="5511457"/>
              <a:ext cx="1597826" cy="133215"/>
            </a:xfrm>
            <a:prstGeom prst="rect">
              <a:avLst/>
            </a:prstGeom>
            <a:ln w="3175">
              <a:noFill/>
            </a:ln>
          </p:spPr>
        </p:pic>
        <p:sp>
          <p:nvSpPr>
            <p:cNvPr id="44" name="矩形 43">
              <a:extLst>
                <a:ext uri="{FF2B5EF4-FFF2-40B4-BE49-F238E27FC236}">
                  <a16:creationId xmlns:a16="http://schemas.microsoft.com/office/drawing/2014/main" id="{1AC5634B-6F92-30DC-8335-29512B5DC01D}"/>
                </a:ext>
              </a:extLst>
            </p:cNvPr>
            <p:cNvSpPr/>
            <p:nvPr/>
          </p:nvSpPr>
          <p:spPr>
            <a:xfrm>
              <a:off x="3526676" y="5511194"/>
              <a:ext cx="1597826" cy="333497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25B6B04A-2761-5A79-182F-9DF1A4F1D6D1}"/>
                </a:ext>
              </a:extLst>
            </p:cNvPr>
            <p:cNvSpPr txBox="1"/>
            <p:nvPr/>
          </p:nvSpPr>
          <p:spPr>
            <a:xfrm>
              <a:off x="3861076" y="5577150"/>
              <a:ext cx="1005676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7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INC FINGER</a:t>
              </a:r>
              <a:endParaRPr lang="zh-CN" altLang="en-US" sz="7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sz="700" b="1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Solyc05g009310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6" name="直接箭头连接符 45">
              <a:extLst>
                <a:ext uri="{FF2B5EF4-FFF2-40B4-BE49-F238E27FC236}">
                  <a16:creationId xmlns:a16="http://schemas.microsoft.com/office/drawing/2014/main" id="{9EE53428-98F2-0AAF-433B-AF17CDC9CCD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63366" y="5273682"/>
              <a:ext cx="224764" cy="75912"/>
            </a:xfrm>
            <a:prstGeom prst="straightConnector1">
              <a:avLst/>
            </a:prstGeom>
            <a:ln w="25400">
              <a:solidFill>
                <a:srgbClr val="C00000"/>
              </a:solidFill>
              <a:headEnd w="lg" len="lg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箭头连接符 46">
              <a:extLst>
                <a:ext uri="{FF2B5EF4-FFF2-40B4-BE49-F238E27FC236}">
                  <a16:creationId xmlns:a16="http://schemas.microsoft.com/office/drawing/2014/main" id="{AB0677FE-03FE-DD95-6C11-7322A6B7AAF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64917" y="4886764"/>
              <a:ext cx="224764" cy="75912"/>
            </a:xfrm>
            <a:prstGeom prst="straightConnector1">
              <a:avLst/>
            </a:prstGeom>
            <a:ln w="25400">
              <a:solidFill>
                <a:srgbClr val="C00000"/>
              </a:solidFill>
              <a:headEnd w="lg" len="lg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接箭头连接符 47">
              <a:extLst>
                <a:ext uri="{FF2B5EF4-FFF2-40B4-BE49-F238E27FC236}">
                  <a16:creationId xmlns:a16="http://schemas.microsoft.com/office/drawing/2014/main" id="{DF9DCC03-F6C7-0C67-3CFE-733AA8E672E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62500" y="4476930"/>
              <a:ext cx="224764" cy="75912"/>
            </a:xfrm>
            <a:prstGeom prst="straightConnector1">
              <a:avLst/>
            </a:prstGeom>
            <a:ln w="25400">
              <a:solidFill>
                <a:srgbClr val="C00000"/>
              </a:solidFill>
              <a:headEnd w="lg" len="lg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接箭头连接符 48">
              <a:extLst>
                <a:ext uri="{FF2B5EF4-FFF2-40B4-BE49-F238E27FC236}">
                  <a16:creationId xmlns:a16="http://schemas.microsoft.com/office/drawing/2014/main" id="{8DD14AA4-97C1-5A47-9903-329DFAD39E2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62500" y="4090012"/>
              <a:ext cx="224764" cy="75912"/>
            </a:xfrm>
            <a:prstGeom prst="straightConnector1">
              <a:avLst/>
            </a:prstGeom>
            <a:ln w="25400">
              <a:solidFill>
                <a:srgbClr val="C00000"/>
              </a:solidFill>
              <a:headEnd w="lg" len="lg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接箭头连接符 49">
              <a:extLst>
                <a:ext uri="{FF2B5EF4-FFF2-40B4-BE49-F238E27FC236}">
                  <a16:creationId xmlns:a16="http://schemas.microsoft.com/office/drawing/2014/main" id="{40064F43-C07D-5269-71C2-16BEB04D46D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83821" y="5294896"/>
              <a:ext cx="224764" cy="75912"/>
            </a:xfrm>
            <a:prstGeom prst="straightConnector1">
              <a:avLst/>
            </a:prstGeom>
            <a:ln w="25400">
              <a:solidFill>
                <a:srgbClr val="C00000"/>
              </a:solidFill>
              <a:headEnd w="lg" len="lg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接箭头连接符 50">
              <a:extLst>
                <a:ext uri="{FF2B5EF4-FFF2-40B4-BE49-F238E27FC236}">
                  <a16:creationId xmlns:a16="http://schemas.microsoft.com/office/drawing/2014/main" id="{83A68029-7EDF-C206-467B-C8400A52B3C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85372" y="4907978"/>
              <a:ext cx="224764" cy="75912"/>
            </a:xfrm>
            <a:prstGeom prst="straightConnector1">
              <a:avLst/>
            </a:prstGeom>
            <a:ln w="25400">
              <a:solidFill>
                <a:srgbClr val="C00000"/>
              </a:solidFill>
              <a:headEnd w="lg" len="lg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接箭头连接符 51">
              <a:extLst>
                <a:ext uri="{FF2B5EF4-FFF2-40B4-BE49-F238E27FC236}">
                  <a16:creationId xmlns:a16="http://schemas.microsoft.com/office/drawing/2014/main" id="{F9205213-B110-D0D3-3C06-E01CC450A1C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82955" y="4498144"/>
              <a:ext cx="224764" cy="75912"/>
            </a:xfrm>
            <a:prstGeom prst="straightConnector1">
              <a:avLst/>
            </a:prstGeom>
            <a:ln w="25400">
              <a:solidFill>
                <a:srgbClr val="C00000"/>
              </a:solidFill>
              <a:headEnd w="lg" len="lg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接箭头连接符 52">
              <a:extLst>
                <a:ext uri="{FF2B5EF4-FFF2-40B4-BE49-F238E27FC236}">
                  <a16:creationId xmlns:a16="http://schemas.microsoft.com/office/drawing/2014/main" id="{A05DD81D-01AB-64C2-918D-1946B61F195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82955" y="4111226"/>
              <a:ext cx="224764" cy="75912"/>
            </a:xfrm>
            <a:prstGeom prst="straightConnector1">
              <a:avLst/>
            </a:prstGeom>
            <a:ln w="25400">
              <a:solidFill>
                <a:srgbClr val="C00000"/>
              </a:solidFill>
              <a:headEnd w="lg" len="lg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0629715E-7012-025E-F67C-1D719C61F45B}"/>
                </a:ext>
              </a:extLst>
            </p:cNvPr>
            <p:cNvSpPr txBox="1"/>
            <p:nvPr/>
          </p:nvSpPr>
          <p:spPr>
            <a:xfrm>
              <a:off x="2974202" y="3837740"/>
              <a:ext cx="46101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[0-5.00]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2E125C6C-87CA-EE2F-8DCF-11325FABCD4A}"/>
                </a:ext>
              </a:extLst>
            </p:cNvPr>
            <p:cNvSpPr txBox="1"/>
            <p:nvPr/>
          </p:nvSpPr>
          <p:spPr>
            <a:xfrm>
              <a:off x="2974202" y="4073595"/>
              <a:ext cx="46101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[0-5.00]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EEF17D43-66BE-DAFC-B628-91AC00F5FE6C}"/>
                </a:ext>
              </a:extLst>
            </p:cNvPr>
            <p:cNvSpPr txBox="1"/>
            <p:nvPr/>
          </p:nvSpPr>
          <p:spPr>
            <a:xfrm>
              <a:off x="2974364" y="4283557"/>
              <a:ext cx="4608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[0-5.00]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5E3411E0-68B4-4DBE-DD02-0F587342DB87}"/>
                </a:ext>
              </a:extLst>
            </p:cNvPr>
            <p:cNvSpPr txBox="1"/>
            <p:nvPr/>
          </p:nvSpPr>
          <p:spPr>
            <a:xfrm>
              <a:off x="2973104" y="4466184"/>
              <a:ext cx="52814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[0-5.00]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2A88BD81-EDC7-A7B2-6226-B057303AABE7}"/>
                </a:ext>
              </a:extLst>
            </p:cNvPr>
            <p:cNvSpPr txBox="1"/>
            <p:nvPr/>
          </p:nvSpPr>
          <p:spPr>
            <a:xfrm>
              <a:off x="2969268" y="4670569"/>
              <a:ext cx="46101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[0-5.00]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79601578-04E5-7A2A-CE0F-41B454601450}"/>
                </a:ext>
              </a:extLst>
            </p:cNvPr>
            <p:cNvSpPr txBox="1"/>
            <p:nvPr/>
          </p:nvSpPr>
          <p:spPr>
            <a:xfrm>
              <a:off x="2969269" y="4867722"/>
              <a:ext cx="46101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[0-5.00]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B29C6E9E-22D7-A29C-907C-28E66B0FF29B}"/>
                </a:ext>
              </a:extLst>
            </p:cNvPr>
            <p:cNvSpPr txBox="1"/>
            <p:nvPr/>
          </p:nvSpPr>
          <p:spPr>
            <a:xfrm>
              <a:off x="2969349" y="5071661"/>
              <a:ext cx="4608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[0-5.00]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BBFD5EB6-15D0-B76B-E612-4939AE406CF2}"/>
                </a:ext>
              </a:extLst>
            </p:cNvPr>
            <p:cNvSpPr txBox="1"/>
            <p:nvPr/>
          </p:nvSpPr>
          <p:spPr>
            <a:xfrm>
              <a:off x="2973104" y="5267543"/>
              <a:ext cx="52814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[0-5.00]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9FEEDC56-2729-A91D-4BF1-D6D5ACFA5886}"/>
                </a:ext>
              </a:extLst>
            </p:cNvPr>
            <p:cNvSpPr txBox="1"/>
            <p:nvPr/>
          </p:nvSpPr>
          <p:spPr>
            <a:xfrm>
              <a:off x="4663485" y="3849917"/>
              <a:ext cx="52704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[0-12.00]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CB09D19F-2B52-559B-5C97-9DFC8BBCC585}"/>
                </a:ext>
              </a:extLst>
            </p:cNvPr>
            <p:cNvSpPr txBox="1"/>
            <p:nvPr/>
          </p:nvSpPr>
          <p:spPr>
            <a:xfrm>
              <a:off x="4663486" y="4085772"/>
              <a:ext cx="5524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[0-12.00]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F54C6DA1-06C5-10D5-7C8A-15CA3A898AD0}"/>
                </a:ext>
              </a:extLst>
            </p:cNvPr>
            <p:cNvSpPr txBox="1"/>
            <p:nvPr/>
          </p:nvSpPr>
          <p:spPr>
            <a:xfrm>
              <a:off x="4663648" y="4295734"/>
              <a:ext cx="5268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[0-12.00]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884D70EB-E3DB-5C34-86B6-1F9D068DD173}"/>
                </a:ext>
              </a:extLst>
            </p:cNvPr>
            <p:cNvSpPr txBox="1"/>
            <p:nvPr/>
          </p:nvSpPr>
          <p:spPr>
            <a:xfrm>
              <a:off x="4662388" y="4478361"/>
              <a:ext cx="52814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[0-12.00]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B1780340-BC3A-55B1-DC55-551BC0DF9F98}"/>
                </a:ext>
              </a:extLst>
            </p:cNvPr>
            <p:cNvSpPr txBox="1"/>
            <p:nvPr/>
          </p:nvSpPr>
          <p:spPr>
            <a:xfrm>
              <a:off x="4658552" y="4682746"/>
              <a:ext cx="5268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[0-12.00]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A631B072-9808-DC2B-3399-4D974FB8D25C}"/>
                </a:ext>
              </a:extLst>
            </p:cNvPr>
            <p:cNvSpPr txBox="1"/>
            <p:nvPr/>
          </p:nvSpPr>
          <p:spPr>
            <a:xfrm>
              <a:off x="4658553" y="4879899"/>
              <a:ext cx="52687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[0-12.00]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62A51B48-73F0-141B-DF11-0285AB39BB4C}"/>
                </a:ext>
              </a:extLst>
            </p:cNvPr>
            <p:cNvSpPr txBox="1"/>
            <p:nvPr/>
          </p:nvSpPr>
          <p:spPr>
            <a:xfrm>
              <a:off x="4658632" y="5083838"/>
              <a:ext cx="52679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[0-12.00]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2697AAAB-80D6-BDB9-B4A2-BDFF0BC39CED}"/>
                </a:ext>
              </a:extLst>
            </p:cNvPr>
            <p:cNvSpPr txBox="1"/>
            <p:nvPr/>
          </p:nvSpPr>
          <p:spPr>
            <a:xfrm>
              <a:off x="4662388" y="5279720"/>
              <a:ext cx="52814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[0-12.00]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0" name="文本框 69">
            <a:extLst>
              <a:ext uri="{FF2B5EF4-FFF2-40B4-BE49-F238E27FC236}">
                <a16:creationId xmlns:a16="http://schemas.microsoft.com/office/drawing/2014/main" id="{6D5E2017-A3A7-A868-1E1C-03D23B4F552E}"/>
              </a:ext>
            </a:extLst>
          </p:cNvPr>
          <p:cNvSpPr txBox="1"/>
          <p:nvPr/>
        </p:nvSpPr>
        <p:spPr>
          <a:xfrm rot="16200000">
            <a:off x="118174" y="1468206"/>
            <a:ext cx="154401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The number of genes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DDC87C05-E450-ECB1-48D9-D0460892A402}"/>
              </a:ext>
            </a:extLst>
          </p:cNvPr>
          <p:cNvSpPr txBox="1"/>
          <p:nvPr/>
        </p:nvSpPr>
        <p:spPr>
          <a:xfrm>
            <a:off x="1366340" y="2375276"/>
            <a:ext cx="14772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rep 1  rep 2  rep 1 rep 2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5F4DF2CA-484F-3852-FF48-A60FE207ACD5}"/>
              </a:ext>
            </a:extLst>
          </p:cNvPr>
          <p:cNvCxnSpPr>
            <a:cxnSpLocks/>
          </p:cNvCxnSpPr>
          <p:nvPr/>
        </p:nvCxnSpPr>
        <p:spPr>
          <a:xfrm>
            <a:off x="1304200" y="2543048"/>
            <a:ext cx="66405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接连接符 72">
            <a:extLst>
              <a:ext uri="{FF2B5EF4-FFF2-40B4-BE49-F238E27FC236}">
                <a16:creationId xmlns:a16="http://schemas.microsoft.com/office/drawing/2014/main" id="{DE3C6987-A57E-E571-AB1A-70B44F335110}"/>
              </a:ext>
            </a:extLst>
          </p:cNvPr>
          <p:cNvCxnSpPr>
            <a:cxnSpLocks/>
          </p:cNvCxnSpPr>
          <p:nvPr/>
        </p:nvCxnSpPr>
        <p:spPr>
          <a:xfrm>
            <a:off x="1997775" y="2543048"/>
            <a:ext cx="52846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矩形 74">
            <a:extLst>
              <a:ext uri="{FF2B5EF4-FFF2-40B4-BE49-F238E27FC236}">
                <a16:creationId xmlns:a16="http://schemas.microsoft.com/office/drawing/2014/main" id="{2D631DD8-EC17-E88E-B3A4-4B4844D041A8}"/>
              </a:ext>
            </a:extLst>
          </p:cNvPr>
          <p:cNvSpPr/>
          <p:nvPr/>
        </p:nvSpPr>
        <p:spPr>
          <a:xfrm>
            <a:off x="1257077" y="2513079"/>
            <a:ext cx="14772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Control    Coronatine </a:t>
            </a:r>
          </a:p>
          <a:p>
            <a:pPr algn="ct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H3K4me3</a:t>
            </a:r>
          </a:p>
        </p:txBody>
      </p:sp>
      <p:pic>
        <p:nvPicPr>
          <p:cNvPr id="76" name="图片 75">
            <a:extLst>
              <a:ext uri="{FF2B5EF4-FFF2-40B4-BE49-F238E27FC236}">
                <a16:creationId xmlns:a16="http://schemas.microsoft.com/office/drawing/2014/main" id="{0A020DA3-DD2D-90A6-0B5C-A127236DDBF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0417" t="8424" r="12861" b="21771"/>
          <a:stretch/>
        </p:blipFill>
        <p:spPr>
          <a:xfrm>
            <a:off x="947724" y="770790"/>
            <a:ext cx="1767114" cy="1657826"/>
          </a:xfrm>
          <a:prstGeom prst="rect">
            <a:avLst/>
          </a:prstGeom>
        </p:spPr>
      </p:pic>
      <p:sp>
        <p:nvSpPr>
          <p:cNvPr id="77" name="文本框 76">
            <a:extLst>
              <a:ext uri="{FF2B5EF4-FFF2-40B4-BE49-F238E27FC236}">
                <a16:creationId xmlns:a16="http://schemas.microsoft.com/office/drawing/2014/main" id="{D966B038-6F63-BE06-D6F3-03172C0E812A}"/>
              </a:ext>
            </a:extLst>
          </p:cNvPr>
          <p:cNvSpPr txBox="1"/>
          <p:nvPr/>
        </p:nvSpPr>
        <p:spPr>
          <a:xfrm>
            <a:off x="580064" y="61320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B28D9DF1-0FA4-96A2-B3A7-DBB4E95A4356}"/>
              </a:ext>
            </a:extLst>
          </p:cNvPr>
          <p:cNvSpPr txBox="1"/>
          <p:nvPr/>
        </p:nvSpPr>
        <p:spPr>
          <a:xfrm>
            <a:off x="580064" y="2960548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17643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92</TotalTime>
  <Words>280</Words>
  <Application>Microsoft Office PowerPoint</Application>
  <PresentationFormat>A4 Paper (210x297 mm)</PresentationFormat>
  <Paragraphs>6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uziyan8028@163.com</dc:creator>
  <cp:lastModifiedBy>MDPI-67</cp:lastModifiedBy>
  <cp:revision>14</cp:revision>
  <dcterms:created xsi:type="dcterms:W3CDTF">2022-04-29T12:10:17Z</dcterms:created>
  <dcterms:modified xsi:type="dcterms:W3CDTF">2022-09-02T12:07:37Z</dcterms:modified>
</cp:coreProperties>
</file>